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8" r:id="rId3"/>
    <p:sldId id="260" r:id="rId4"/>
    <p:sldId id="259" r:id="rId5"/>
    <p:sldId id="257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>
          <p15:clr>
            <a:srgbClr val="A4A3A4"/>
          </p15:clr>
        </p15:guide>
        <p15:guide id="2" pos="66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3512" autoAdjust="0"/>
  </p:normalViewPr>
  <p:slideViewPr>
    <p:cSldViewPr>
      <p:cViewPr varScale="1">
        <p:scale>
          <a:sx n="46" d="100"/>
          <a:sy n="46" d="100"/>
        </p:scale>
        <p:origin x="1243" y="46"/>
      </p:cViewPr>
      <p:guideLst>
        <p:guide orient="horz" pos="2835"/>
        <p:guide pos="66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ysClr val="window" lastClr="FFFFFF">
                <a:lumMod val="65000"/>
              </a:sys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4!$C$4:$C$8</c:f>
                <c:numCache>
                  <c:formatCode>General</c:formatCode>
                  <c:ptCount val="5"/>
                  <c:pt idx="0">
                    <c:v>1.1689983107732673E-2</c:v>
                  </c:pt>
                  <c:pt idx="2">
                    <c:v>7.9034161872664502E-2</c:v>
                  </c:pt>
                  <c:pt idx="3">
                    <c:v>0.12736200306388823</c:v>
                  </c:pt>
                  <c:pt idx="4">
                    <c:v>0.13000753121897829</c:v>
                  </c:pt>
                </c:numCache>
              </c:numRef>
            </c:plus>
            <c:minus>
              <c:numRef>
                <c:f>Sheet4!$C$4:$C$8</c:f>
                <c:numCache>
                  <c:formatCode>General</c:formatCode>
                  <c:ptCount val="5"/>
                  <c:pt idx="0">
                    <c:v>1.1689983107732673E-2</c:v>
                  </c:pt>
                  <c:pt idx="2">
                    <c:v>7.9034161872664502E-2</c:v>
                  </c:pt>
                  <c:pt idx="3">
                    <c:v>0.12736200306388823</c:v>
                  </c:pt>
                  <c:pt idx="4">
                    <c:v>0.130007531218978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4!$B$4:$B$8</c:f>
              <c:numCache>
                <c:formatCode>General</c:formatCode>
                <c:ptCount val="5"/>
                <c:pt idx="0" formatCode="0.00">
                  <c:v>0.50895629690566035</c:v>
                </c:pt>
                <c:pt idx="2" formatCode="0.00">
                  <c:v>1.0620949626498952</c:v>
                </c:pt>
                <c:pt idx="3" formatCode="0.00">
                  <c:v>0.90667625266247376</c:v>
                </c:pt>
                <c:pt idx="4" formatCode="0.00">
                  <c:v>0.25904429494339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6"/>
        <c:axId val="640832528"/>
        <c:axId val="911207872"/>
      </c:barChart>
      <c:catAx>
        <c:axId val="64083252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1207872"/>
        <c:crosses val="autoZero"/>
        <c:auto val="1"/>
        <c:lblAlgn val="ctr"/>
        <c:lblOffset val="100"/>
        <c:noMultiLvlLbl val="0"/>
      </c:catAx>
      <c:valAx>
        <c:axId val="911207872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>
                <a:lumMod val="65000"/>
                <a:lumOff val="3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08325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49365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5994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68720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38CBA6-4FCF-4E66-BE97-E7AB9390DA04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7F1D9E-778E-4A59-9D1E-4B201A7F72F5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435841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B91018-BF3A-45C9-85AA-350CBE8D0A4F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FDB12F-D60C-4716-BE64-EEFB9AEDEB23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8547226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6A05B8-599B-4A16-9FA1-285123FA8E4B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C2E226-6BB2-4DA2-990C-EB35AE37AEC0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70215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6678A4-1C0C-4C13-8263-679877E9C3BF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C7DB4D-5A99-45E9-BA79-BCB01B903809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7405777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38F04A-FDB3-445A-9E14-2B4F556EFF05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81456F-A6C4-4537-B909-FC6CB307DAB6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4791660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009BDD-9F47-4339-A299-3E227E3E611B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A7B962-D221-4430-8CC2-54633A3197EB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0130774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9A49A8-4327-4E1D-B9E3-8F356428247D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9AFEB6-63FB-4DF7-A647-F7F5EE979060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604328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AA59AD-A91F-4438-997C-FEABE9D7852F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3E5774-DAFA-498A-A3AF-815EEB85919D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35933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393879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4AF250-9EF4-4AB0-BEC9-8AB8109FE04C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8C2959-25E2-49DC-9BA8-DAA371EF3698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0903436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1238C-7161-4DE8-87CB-C57753BC082D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31A1C3-5F1E-4FEB-95C9-9A3420268901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464275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D0F7F5-2B67-44DC-9315-AC39841F9C3B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4C8D52-6C4C-4178-B272-1D157761645F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836799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3382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3797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7010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10030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9750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091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0729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F795AF-C6E7-413F-94D4-BE59D66006E6}" type="datetimeFigureOut">
              <a:rPr lang="en-GB" smtClean="0"/>
              <a:t>07/03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8EE1DD-8932-4164-B984-00FF982210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8743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B3D723EC-C79A-4F99-85F3-92334D6D3403}" type="datetimeFigureOut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07/03/20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017605BE-2C19-4CD6-8D09-2EE6F78B9B3A}" type="slidenum">
              <a:rPr lang="en-GB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69134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72" charset="-128"/>
          <a:cs typeface="ＭＳ Ｐゴシック" pitchFamily="-72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3200" kern="1200">
          <a:solidFill>
            <a:schemeClr val="tx1"/>
          </a:solidFill>
          <a:latin typeface="+mn-lt"/>
          <a:ea typeface="ＭＳ Ｐゴシック" pitchFamily="-72" charset="-128"/>
          <a:cs typeface="ＭＳ Ｐゴシック" pitchFamily="-72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8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24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»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8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microsoft.com/office/2007/relationships/hdphoto" Target="../media/hdphoto3.wdp"/><Relationship Id="rId5" Type="http://schemas.openxmlformats.org/officeDocument/2006/relationships/image" Target="../media/image3.png"/><Relationship Id="rId10" Type="http://schemas.openxmlformats.org/officeDocument/2006/relationships/image" Target="../media/image7.jpeg"/><Relationship Id="rId4" Type="http://schemas.microsoft.com/office/2007/relationships/hdphoto" Target="../media/hdphoto1.wdp"/><Relationship Id="rId9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64704" y="816551"/>
            <a:ext cx="49685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 smtClean="0"/>
              <a:t>Mohd Salleh et al. Additional Table 1 – primers used for RT-PCR</a:t>
            </a:r>
            <a:endParaRPr lang="en-GB" sz="1200" i="1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1423793"/>
              </p:ext>
            </p:extLst>
          </p:nvPr>
        </p:nvGraphicFramePr>
        <p:xfrm>
          <a:off x="764704" y="1331640"/>
          <a:ext cx="5040560" cy="41656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52127"/>
                <a:gridCol w="2105981"/>
                <a:gridCol w="1782452"/>
              </a:tblGrid>
              <a:tr h="370840"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primer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sequence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Reference or gene accession no.</a:t>
                      </a:r>
                      <a:endParaRPr lang="en-GB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AtSAG21F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ATCTTCCGACGTGGTTATGC 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WFSAG21</a:t>
                      </a:r>
                      <a:r>
                        <a:rPr lang="en-GB" sz="1200" dirty="0" smtClean="0"/>
                        <a:t>; AM747887</a:t>
                      </a:r>
                      <a:endParaRPr lang="en-GB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AtSAG21R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CCGGTTTCGGGTCTGTAATA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20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WFSAG12F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TTGCCGGTTTCTGTTGAYTGG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WFSAG12;  </a:t>
                      </a:r>
                      <a:r>
                        <a:rPr lang="en-GB" sz="1200" i="0" dirty="0" smtClean="0"/>
                        <a:t>[30]</a:t>
                      </a:r>
                      <a:endParaRPr lang="en-GB" sz="1200" i="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WFSAG12R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TGGTGTGCCACTGCYTTCAT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20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WLS73F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GGCACCTAGACCGAGGATTT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WLS73; </a:t>
                      </a:r>
                      <a:r>
                        <a:rPr lang="en-GB" sz="1200" dirty="0" smtClean="0"/>
                        <a:t>AM747819</a:t>
                      </a:r>
                      <a:endParaRPr lang="en-GB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WLS73R</a:t>
                      </a:r>
                      <a:r>
                        <a:rPr lang="en-GB" sz="1200" dirty="0" smtClean="0"/>
                        <a:t> 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TTCCATCGAGGCCTTTCTTA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WPS46F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GCTCCGATCATTGAGCTTTT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WPS46; </a:t>
                      </a:r>
                      <a:r>
                        <a:rPr lang="en-GB" sz="1200" dirty="0" smtClean="0"/>
                        <a:t>AM747914 </a:t>
                      </a:r>
                      <a:endParaRPr lang="en-GB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WPS46R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TTCAAATGGGACTAGAAACCTTC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PUV2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TTCCATGCTAATGTATTCAGAG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18S </a:t>
                      </a:r>
                      <a:r>
                        <a:rPr lang="en-GB" sz="1200" dirty="0" err="1" smtClean="0"/>
                        <a:t>rRNA</a:t>
                      </a:r>
                      <a:r>
                        <a:rPr lang="en-GB" sz="1200" dirty="0" smtClean="0"/>
                        <a:t> primers ; </a:t>
                      </a:r>
                      <a:r>
                        <a:rPr lang="en-GB" sz="1200" smtClean="0"/>
                        <a:t>[3]</a:t>
                      </a:r>
                      <a:endParaRPr lang="en-GB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GB" sz="1200" i="1" cap="all" dirty="0" smtClean="0"/>
                        <a:t>puv</a:t>
                      </a:r>
                      <a:r>
                        <a:rPr lang="en-GB" sz="1200" i="1" dirty="0" smtClean="0"/>
                        <a:t>4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 smtClean="0"/>
                        <a:t>ATGGTGGTGACGGGTGAC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200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044354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486384" y="3038161"/>
            <a:ext cx="21138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GB" sz="900" b="1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Ethylene (</a:t>
            </a:r>
            <a:r>
              <a:rPr lang="en-GB" sz="900" b="1" dirty="0" err="1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nL</a:t>
            </a:r>
            <a:r>
              <a:rPr lang="en-GB" sz="900" b="1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 g FW </a:t>
            </a:r>
            <a:r>
              <a:rPr lang="en-GB" sz="900" b="1" baseline="30000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-1</a:t>
            </a:r>
            <a:r>
              <a:rPr lang="en-GB" sz="900" b="1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 h </a:t>
            </a:r>
            <a:r>
              <a:rPr lang="en-GB" sz="900" b="1" baseline="30000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-1</a:t>
            </a:r>
            <a:r>
              <a:rPr lang="en-GB" sz="900" b="1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)</a:t>
            </a:r>
            <a:endParaRPr lang="en-GB" sz="900" b="1" dirty="0">
              <a:solidFill>
                <a:prstClr val="black"/>
              </a:solidFill>
              <a:latin typeface="Arial" pitchFamily="-72" charset="0"/>
              <a:ea typeface="ＭＳ Ｐゴシック" pitchFamily="-72" charset="-128"/>
            </a:endParaRPr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1714002" y="2704324"/>
          <a:ext cx="3290541" cy="1941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237785" y="5497551"/>
            <a:ext cx="469466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GB" sz="1200" i="1" dirty="0"/>
              <a:t>Mohd Salleh et al. Additional Figure</a:t>
            </a:r>
            <a:r>
              <a:rPr lang="en-GB" sz="1200" b="1" i="1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 </a:t>
            </a:r>
            <a:r>
              <a:rPr lang="en-GB" sz="1200" i="1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1.</a:t>
            </a:r>
            <a:r>
              <a:rPr lang="en-GB" sz="1200" b="1" i="1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 </a:t>
            </a:r>
            <a:r>
              <a:rPr lang="en-GB" sz="1200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Ethylene production by whole isolated flowers at four developmental stages: </a:t>
            </a:r>
            <a:r>
              <a:rPr lang="en-GB" sz="1200" dirty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stages in wallflower senescence: stage 1 – fully open pale flowers; 4/6 anthers </a:t>
            </a:r>
            <a:r>
              <a:rPr lang="en-GB" sz="1200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protruding; </a:t>
            </a:r>
            <a:r>
              <a:rPr lang="en-GB" sz="1200" dirty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stage 3 – petals held more loosely, beginning to wilt, darker; stage 4 – petals limp and curled over, darker colour, wilting clearly evident; stage 5 – clear petal </a:t>
            </a:r>
            <a:r>
              <a:rPr lang="en-GB" sz="1200" dirty="0" smtClean="0">
                <a:solidFill>
                  <a:prstClr val="black"/>
                </a:solidFill>
                <a:latin typeface="Arial" pitchFamily="-72" charset="0"/>
                <a:ea typeface="ＭＳ Ｐゴシック" pitchFamily="-72" charset="-128"/>
              </a:rPr>
              <a:t>deterioration. 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GB" sz="1200" dirty="0">
              <a:solidFill>
                <a:prstClr val="black"/>
              </a:solidFill>
              <a:latin typeface="Arial" pitchFamily="-72" charset="0"/>
              <a:ea typeface="ＭＳ Ｐゴシック" pitchFamily="-72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7340396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86880" y="4990909"/>
            <a:ext cx="403244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 smtClean="0"/>
              <a:t>Mohd Salleh et al. Additional </a:t>
            </a:r>
            <a:r>
              <a:rPr lang="en-GB" sz="1200" i="1" dirty="0"/>
              <a:t>Figure </a:t>
            </a:r>
            <a:r>
              <a:rPr lang="en-GB" sz="1200" i="1" dirty="0" smtClean="0"/>
              <a:t>2: </a:t>
            </a:r>
            <a:r>
              <a:rPr lang="en-GB" sz="1200" dirty="0"/>
              <a:t>Effect of different </a:t>
            </a:r>
            <a:r>
              <a:rPr lang="en-GB" sz="1200" dirty="0" smtClean="0"/>
              <a:t>NAA </a:t>
            </a:r>
            <a:r>
              <a:rPr lang="en-GB" sz="1200" dirty="0"/>
              <a:t>concentrations on progression of petal senescence in detached flowers</a:t>
            </a:r>
            <a:r>
              <a:rPr lang="en-GB" sz="1200" dirty="0" smtClean="0"/>
              <a:t>. Flowers were  detached at Stage 1 and treated continuously for 4 days</a:t>
            </a:r>
            <a:endParaRPr lang="en-GB" sz="1200" dirty="0"/>
          </a:p>
          <a:p>
            <a:endParaRPr lang="en-GB" sz="1200" dirty="0"/>
          </a:p>
        </p:txBody>
      </p:sp>
      <p:pic>
        <p:nvPicPr>
          <p:cNvPr id="3" name="Picture 11" descr="SDC12816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1080480" y="3355800"/>
            <a:ext cx="812800" cy="882651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7" descr="DSCN526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2287414" y="1530350"/>
            <a:ext cx="927100" cy="1119808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407866" y="2642692"/>
            <a:ext cx="79208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13.4 </a:t>
            </a:r>
            <a:r>
              <a:rPr lang="en-GB" sz="1400" dirty="0" err="1" smtClean="0"/>
              <a:t>nM</a:t>
            </a:r>
            <a:endParaRPr lang="en-GB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3583930" y="2627784"/>
            <a:ext cx="79208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134 </a:t>
            </a:r>
            <a:r>
              <a:rPr lang="en-GB" sz="1400" dirty="0" err="1" smtClean="0"/>
              <a:t>nM</a:t>
            </a:r>
            <a:endParaRPr lang="en-GB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3331592" y="4211389"/>
            <a:ext cx="79208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26 µM</a:t>
            </a:r>
            <a:endParaRPr lang="en-GB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2204864" y="4211389"/>
            <a:ext cx="79208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13 µM</a:t>
            </a:r>
            <a:endParaRPr lang="en-GB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4401046" y="4211389"/>
            <a:ext cx="79208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52 µM</a:t>
            </a:r>
            <a:endParaRPr lang="en-GB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1124744" y="4211960"/>
            <a:ext cx="7920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water</a:t>
            </a:r>
            <a:endParaRPr lang="en-GB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1266602" y="2627784"/>
            <a:ext cx="79208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water</a:t>
            </a:r>
            <a:endParaRPr lang="en-GB" sz="1400" dirty="0"/>
          </a:p>
        </p:txBody>
      </p:sp>
      <p:pic>
        <p:nvPicPr>
          <p:cNvPr id="8" name="Picture 7" descr="flower H2O 13NAA.png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70956" y="3347864"/>
            <a:ext cx="810146" cy="889957"/>
          </a:xfrm>
          <a:prstGeom prst="rect">
            <a:avLst/>
          </a:prstGeom>
        </p:spPr>
      </p:pic>
      <p:pic>
        <p:nvPicPr>
          <p:cNvPr id="14" name="Picture 11" descr="SDC12816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3252924" y="3347864"/>
            <a:ext cx="809352" cy="890587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1" descr="SDC12816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4329038" y="3347864"/>
            <a:ext cx="810642" cy="890587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7" descr="DSCN5262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1089894" y="1530350"/>
            <a:ext cx="918790" cy="1122016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7" descr="DSCN5262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3511550" y="1530350"/>
            <a:ext cx="917922" cy="1119808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754815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0" name="Text Box 4"/>
          <p:cNvSpPr txBox="1">
            <a:spLocks noChangeArrowheads="1"/>
          </p:cNvSpPr>
          <p:nvPr/>
        </p:nvSpPr>
        <p:spPr bwMode="auto">
          <a:xfrm>
            <a:off x="2762250" y="5162550"/>
            <a:ext cx="1676400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GB" sz="1400">
                <a:latin typeface="Arial" charset="0"/>
                <a:ea typeface="ＭＳ Ｐゴシック" charset="0"/>
              </a:rPr>
              <a:t>Suppl. Figure 1</a:t>
            </a:r>
          </a:p>
        </p:txBody>
      </p:sp>
      <p:graphicFrame>
        <p:nvGraphicFramePr>
          <p:cNvPr id="8194" name="Object 5"/>
          <p:cNvGraphicFramePr>
            <a:graphicFrameLocks noChangeAspect="1"/>
          </p:cNvGraphicFramePr>
          <p:nvPr/>
        </p:nvGraphicFramePr>
        <p:xfrm>
          <a:off x="423863" y="1152525"/>
          <a:ext cx="5838825" cy="3962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name="Chart" r:id="rId3" imgW="5854700" imgH="3975100" progId="Excel.Chart.8">
                  <p:embed/>
                </p:oleObj>
              </mc:Choice>
              <mc:Fallback>
                <p:oleObj name="Chart" r:id="rId3" imgW="5854700" imgH="3975100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3863" y="1152525"/>
                        <a:ext cx="5838825" cy="3962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=""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=""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="" xmlns:a14="http://schemas.microsoft.com/office/drawing/2010/main">
                            <a:effectLst>
                              <a:outerShdw dist="35921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340768" y="5940152"/>
            <a:ext cx="40324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 smtClean="0"/>
              <a:t>Mohd Salleh et al. Additional </a:t>
            </a:r>
            <a:r>
              <a:rPr lang="en-GB" sz="1200" i="1" dirty="0"/>
              <a:t>Figure </a:t>
            </a:r>
            <a:r>
              <a:rPr lang="en-GB" sz="1200" i="1" dirty="0" smtClean="0"/>
              <a:t>3: </a:t>
            </a:r>
            <a:r>
              <a:rPr lang="en-GB" sz="1200" dirty="0"/>
              <a:t>Effect of different CEPA concentrations on progression of petal senescence in detached flowers.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397478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221</Words>
  <Application>Microsoft Office PowerPoint</Application>
  <PresentationFormat>On-screen Show (4:3)</PresentationFormat>
  <Paragraphs>41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ＭＳ Ｐゴシック</vt:lpstr>
      <vt:lpstr>Arial</vt:lpstr>
      <vt:lpstr>Calibri</vt:lpstr>
      <vt:lpstr>Office Theme</vt:lpstr>
      <vt:lpstr>1_Office Theme</vt:lpstr>
      <vt:lpstr>Chart</vt:lpstr>
      <vt:lpstr>PowerPoint Presentation</vt:lpstr>
      <vt:lpstr>PowerPoint Presentation</vt:lpstr>
      <vt:lpstr>PowerPoint Presentation</vt:lpstr>
      <vt:lpstr>PowerPoint Presentation</vt:lpstr>
    </vt:vector>
  </TitlesOfParts>
  <Company>Cardiff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srv</dc:creator>
  <cp:lastModifiedBy>HJR</cp:lastModifiedBy>
  <cp:revision>21</cp:revision>
  <dcterms:created xsi:type="dcterms:W3CDTF">2014-09-04T18:39:43Z</dcterms:created>
  <dcterms:modified xsi:type="dcterms:W3CDTF">2016-03-07T10:28:41Z</dcterms:modified>
</cp:coreProperties>
</file>